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>
      <p:cViewPr varScale="1">
        <p:scale>
          <a:sx n="95" d="100"/>
          <a:sy n="95" d="100"/>
        </p:scale>
        <p:origin x="2934" y="114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2.tif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 rot="16200000">
            <a:off x="118552" y="5667052"/>
            <a:ext cx="19123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umulative tissue injury index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519" y="71128"/>
            <a:ext cx="2011680" cy="201168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767" y="2468292"/>
            <a:ext cx="2103120" cy="21031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186" y="71128"/>
            <a:ext cx="2011680" cy="20116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5327" y="2468292"/>
            <a:ext cx="2103120" cy="210312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D96C5C15-3CE6-0B4C-94B3-B8690C794626}"/>
              </a:ext>
            </a:extLst>
          </p:cNvPr>
          <p:cNvSpPr txBox="1"/>
          <p:nvPr/>
        </p:nvSpPr>
        <p:spPr>
          <a:xfrm>
            <a:off x="998537" y="2096960"/>
            <a:ext cx="20111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32137" y="2082314"/>
            <a:ext cx="2179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KO, water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96C5C15-3CE6-0B4C-94B3-B8690C794626}"/>
              </a:ext>
            </a:extLst>
          </p:cNvPr>
          <p:cNvSpPr txBox="1"/>
          <p:nvPr/>
        </p:nvSpPr>
        <p:spPr>
          <a:xfrm>
            <a:off x="3208337" y="4601837"/>
            <a:ext cx="2126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O,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96C5C15-3CE6-0B4C-94B3-B8690C794626}"/>
              </a:ext>
            </a:extLst>
          </p:cNvPr>
          <p:cNvSpPr txBox="1"/>
          <p:nvPr/>
        </p:nvSpPr>
        <p:spPr>
          <a:xfrm>
            <a:off x="1074737" y="4571609"/>
            <a:ext cx="19404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+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96C5C15-3CE6-0B4C-94B3-B8690C794626}"/>
              </a:ext>
            </a:extLst>
          </p:cNvPr>
          <p:cNvSpPr txBox="1"/>
          <p:nvPr/>
        </p:nvSpPr>
        <p:spPr>
          <a:xfrm>
            <a:off x="3477129" y="5309470"/>
            <a:ext cx="2474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O,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SS (11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D96C5C15-3CE6-0B4C-94B3-B8690C794626}"/>
              </a:ext>
            </a:extLst>
          </p:cNvPr>
          <p:cNvSpPr txBox="1"/>
          <p:nvPr/>
        </p:nvSpPr>
        <p:spPr>
          <a:xfrm>
            <a:off x="3486340" y="5019034"/>
            <a:ext cx="2236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SS (9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3296169" y="5421644"/>
            <a:ext cx="205740" cy="0"/>
          </a:xfrm>
          <a:prstGeom prst="line">
            <a:avLst/>
          </a:prstGeom>
          <a:ln w="635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296169" y="5188311"/>
            <a:ext cx="205740" cy="0"/>
          </a:xfrm>
          <a:prstGeom prst="line">
            <a:avLst/>
          </a:prstGeom>
          <a:ln w="635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1043" y="7130307"/>
            <a:ext cx="614218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Tissue histology of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mal and post-DS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covere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onic mucosa in control and P-cadherin knockout mice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E stained distal colonic sections of either control mice, or animals recovered for 8 days after DSS colitis. (B) 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lculated tissue injury index. Mea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;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, p=0.351. Number of animals are indicated in parenthesis. Scale bar, 500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 are combined from two independent experiment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60337" y="4771114"/>
            <a:ext cx="49244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B</a:t>
            </a:r>
          </a:p>
        </p:txBody>
      </p:sp>
      <p:sp>
        <p:nvSpPr>
          <p:cNvPr id="25" name="Rectangle 24"/>
          <p:cNvSpPr/>
          <p:nvPr/>
        </p:nvSpPr>
        <p:spPr>
          <a:xfrm>
            <a:off x="147194" y="-29560"/>
            <a:ext cx="49244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A</a:t>
            </a:r>
          </a:p>
        </p:txBody>
      </p:sp>
      <p:cxnSp>
        <p:nvCxnSpPr>
          <p:cNvPr id="27" name="Straight Connector 26"/>
          <p:cNvCxnSpPr/>
          <p:nvPr/>
        </p:nvCxnSpPr>
        <p:spPr>
          <a:xfrm flipV="1">
            <a:off x="2092194" y="5322080"/>
            <a:ext cx="537144" cy="326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161633" y="4972844"/>
            <a:ext cx="531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n.s</a:t>
            </a:r>
            <a:r>
              <a:rPr lang="en-US" dirty="0" smtClean="0"/>
              <a:t>.</a:t>
            </a:r>
            <a:endParaRPr lang="en-US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618689"/>
              </p:ext>
            </p:extLst>
          </p:nvPr>
        </p:nvGraphicFramePr>
        <p:xfrm>
          <a:off x="1321468" y="4896644"/>
          <a:ext cx="2060575" cy="245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9" r:id="rId7" imgW="2061057" imgH="2453009" progId="Prism9.Document">
                  <p:embed/>
                </p:oleObj>
              </mc:Choice>
              <mc:Fallback>
                <p:oleObj name="Prism 9" r:id="rId7" imgW="2061057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21468" y="4896644"/>
                        <a:ext cx="2060575" cy="245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890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8</TotalTime>
  <Words>119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Symbol</vt:lpstr>
      <vt:lpstr>Office Theme</vt:lpstr>
      <vt:lpstr>Prism 9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Ivanov, Andrei</cp:lastModifiedBy>
  <cp:revision>229</cp:revision>
  <cp:lastPrinted>2022-04-19T18:59:42Z</cp:lastPrinted>
  <dcterms:created xsi:type="dcterms:W3CDTF">2012-06-22T16:30:39Z</dcterms:created>
  <dcterms:modified xsi:type="dcterms:W3CDTF">2022-04-20T13:11:31Z</dcterms:modified>
</cp:coreProperties>
</file>